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73" d="100"/>
          <a:sy n="73" d="100"/>
        </p:scale>
        <p:origin x="176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FE569F-8633-4804-AE40-9BEF9B8C458C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88B0C7-1939-4187-9FFA-C720612A4A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8227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8AF2C-48E2-4518-AAAD-588DED012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346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60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965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472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7526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3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84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359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1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05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72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C926C6-5E0D-4EEB-B7E8-C287EA6858D9}" type="datetimeFigureOut">
              <a:rPr lang="zh-CN" altLang="en-US" smtClean="0"/>
              <a:t>2025/5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E328F-1E76-43FC-B939-E66EA17B23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658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4C53DB3-8C79-8F5D-9EDC-877A01116148}"/>
              </a:ext>
            </a:extLst>
          </p:cNvPr>
          <p:cNvSpPr txBox="1"/>
          <p:nvPr/>
        </p:nvSpPr>
        <p:spPr>
          <a:xfrm>
            <a:off x="125600" y="1207341"/>
            <a:ext cx="4624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blots for Figure_4I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A6917708-20A6-7ED7-49EA-66458A4754C4}"/>
              </a:ext>
            </a:extLst>
          </p:cNvPr>
          <p:cNvGrpSpPr/>
          <p:nvPr/>
        </p:nvGrpSpPr>
        <p:grpSpPr>
          <a:xfrm>
            <a:off x="987892" y="1899686"/>
            <a:ext cx="4103234" cy="3720695"/>
            <a:chOff x="987892" y="1899686"/>
            <a:chExt cx="4103234" cy="3720695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C55DB5A3-80BB-4578-F401-A3CB84A50B21}"/>
                </a:ext>
              </a:extLst>
            </p:cNvPr>
            <p:cNvGrpSpPr/>
            <p:nvPr/>
          </p:nvGrpSpPr>
          <p:grpSpPr>
            <a:xfrm>
              <a:off x="987892" y="1899686"/>
              <a:ext cx="4103234" cy="3720695"/>
              <a:chOff x="987892" y="1899686"/>
              <a:chExt cx="4103234" cy="3720695"/>
            </a:xfrm>
          </p:grpSpPr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FD431D07-34F1-609C-E0B4-573188353ECA}"/>
                  </a:ext>
                </a:extLst>
              </p:cNvPr>
              <p:cNvGrpSpPr/>
              <p:nvPr/>
            </p:nvGrpSpPr>
            <p:grpSpPr>
              <a:xfrm>
                <a:off x="987892" y="1899686"/>
                <a:ext cx="4060819" cy="3720695"/>
                <a:chOff x="987892" y="1899686"/>
                <a:chExt cx="4060819" cy="3720695"/>
              </a:xfrm>
            </p:grpSpPr>
            <p:grpSp>
              <p:nvGrpSpPr>
                <p:cNvPr id="12" name="组合 11">
                  <a:extLst>
                    <a:ext uri="{FF2B5EF4-FFF2-40B4-BE49-F238E27FC236}">
                      <a16:creationId xmlns:a16="http://schemas.microsoft.com/office/drawing/2014/main" id="{C2DB13D7-B0AD-3813-1202-2B1E000EC254}"/>
                    </a:ext>
                  </a:extLst>
                </p:cNvPr>
                <p:cNvGrpSpPr/>
                <p:nvPr/>
              </p:nvGrpSpPr>
              <p:grpSpPr>
                <a:xfrm>
                  <a:off x="987892" y="1899686"/>
                  <a:ext cx="4060819" cy="3720695"/>
                  <a:chOff x="987892" y="1899686"/>
                  <a:chExt cx="4060819" cy="3720695"/>
                </a:xfrm>
              </p:grpSpPr>
              <p:grpSp>
                <p:nvGrpSpPr>
                  <p:cNvPr id="44" name="组合 43">
                    <a:extLst>
                      <a:ext uri="{FF2B5EF4-FFF2-40B4-BE49-F238E27FC236}">
                        <a16:creationId xmlns:a16="http://schemas.microsoft.com/office/drawing/2014/main" id="{484C120E-AFA3-4967-1D8C-A68CCB565794}"/>
                      </a:ext>
                    </a:extLst>
                  </p:cNvPr>
                  <p:cNvGrpSpPr/>
                  <p:nvPr/>
                </p:nvGrpSpPr>
                <p:grpSpPr>
                  <a:xfrm>
                    <a:off x="987892" y="1899686"/>
                    <a:ext cx="4060819" cy="3720695"/>
                    <a:chOff x="4514863" y="808522"/>
                    <a:chExt cx="4060819" cy="3720695"/>
                  </a:xfrm>
                </p:grpSpPr>
                <p:graphicFrame>
                  <p:nvGraphicFramePr>
                    <p:cNvPr id="3" name="对象 2">
                      <a:extLst>
                        <a:ext uri="{FF2B5EF4-FFF2-40B4-BE49-F238E27FC236}">
                          <a16:creationId xmlns:a16="http://schemas.microsoft.com/office/drawing/2014/main" id="{9F3E52A6-73AF-DC6E-DDD3-C3289679095C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770375058"/>
                        </p:ext>
                      </p:extLst>
                    </p:nvPr>
                  </p:nvGraphicFramePr>
                  <p:xfrm>
                    <a:off x="5391981" y="2058958"/>
                    <a:ext cx="2160000" cy="873976"/>
                  </p:xfrm>
                  <a:graphic>
                    <a:graphicData uri="http://schemas.openxmlformats.org/presentationml/2006/ole">
                      <mc:AlternateContent xmlns:mc="http://schemas.openxmlformats.org/markup-compatibility/2006">
                        <mc:Choice xmlns:v="urn:schemas-microsoft-com:vml" Requires="v">
                          <p:oleObj name="Image" r:id="rId3" imgW="6600030" imgH="2669787" progId="Photoshop.Image.13">
                            <p:embed/>
                          </p:oleObj>
                        </mc:Choice>
                        <mc:Fallback>
                          <p:oleObj name="Image" r:id="rId3" imgW="6600030" imgH="2669787" progId="Photoshop.Image.13">
                            <p:embed/>
                            <p:pic>
                              <p:nvPicPr>
                                <p:cNvPr id="5" name="对象 4">
                                  <a:extLst>
                                    <a:ext uri="{FF2B5EF4-FFF2-40B4-BE49-F238E27FC236}">
                                      <a16:creationId xmlns:a16="http://schemas.microsoft.com/office/drawing/2014/main" id="{41C4438E-5CEA-6141-F03D-5A328E95FC22}"/>
                                    </a:ext>
                                  </a:extLst>
                                </p:cNvPr>
                                <p:cNvPicPr/>
                                <p:nvPr/>
                              </p:nvPicPr>
                              <p:blipFill>
                                <a:blip r:embed="rId4">
                                  <a:lum/>
                                </a:blip>
                                <a:stretch>
                                  <a:fillRect/>
                                </a:stretch>
                              </p:blipFill>
                              <p:spPr>
                                <a:xfrm>
                                  <a:off x="5391981" y="2058958"/>
                                  <a:ext cx="2160000" cy="873976"/>
                                </a:xfrm>
                                <a:prstGeom prst="rect">
                                  <a:avLst/>
                                </a:prstGeom>
                              </p:spPr>
                            </p:pic>
                          </p:oleObj>
                        </mc:Fallback>
                      </mc:AlternateContent>
                    </a:graphicData>
                  </a:graphic>
                </p:graphicFrame>
                <p:grpSp>
                  <p:nvGrpSpPr>
                    <p:cNvPr id="5" name="组合 4">
                      <a:extLst>
                        <a:ext uri="{FF2B5EF4-FFF2-40B4-BE49-F238E27FC236}">
                          <a16:creationId xmlns:a16="http://schemas.microsoft.com/office/drawing/2014/main" id="{95D3F07A-EDB5-CED3-9507-6B300207611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14863" y="808522"/>
                      <a:ext cx="4060819" cy="3720695"/>
                      <a:chOff x="1135566" y="1297597"/>
                      <a:chExt cx="4060819" cy="3720695"/>
                    </a:xfrm>
                  </p:grpSpPr>
                  <p:pic>
                    <p:nvPicPr>
                      <p:cNvPr id="6" name="图片 5">
                        <a:extLst>
                          <a:ext uri="{FF2B5EF4-FFF2-40B4-BE49-F238E27FC236}">
                            <a16:creationId xmlns:a16="http://schemas.microsoft.com/office/drawing/2014/main" id="{C8EE725B-67D5-4175-0266-7EEE817AD27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/>
                      <a:srcRect l="63903" t="-1965" b="1"/>
                      <a:stretch/>
                    </p:blipFill>
                    <p:spPr>
                      <a:xfrm>
                        <a:off x="2034732" y="1872211"/>
                        <a:ext cx="2147054" cy="63184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8" name="图片 7">
                        <a:extLst>
                          <a:ext uri="{FF2B5EF4-FFF2-40B4-BE49-F238E27FC236}">
                            <a16:creationId xmlns:a16="http://schemas.microsoft.com/office/drawing/2014/main" id="{5C8DC2CA-D682-6D5D-875D-1BAC372223BD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6"/>
                      <a:srcRect l="62806" t="-2951" r="79" b="10848"/>
                      <a:stretch/>
                    </p:blipFill>
                    <p:spPr>
                      <a:xfrm rot="21300000">
                        <a:off x="2018540" y="4323811"/>
                        <a:ext cx="2160000" cy="694481"/>
                      </a:xfrm>
                      <a:custGeom>
                        <a:avLst/>
                        <a:gdLst>
                          <a:gd name="connsiteX0" fmla="*/ 44803 w 2171434"/>
                          <a:gd name="connsiteY0" fmla="*/ 0 h 698157"/>
                          <a:gd name="connsiteX1" fmla="*/ 2171434 w 2171434"/>
                          <a:gd name="connsiteY1" fmla="*/ 186056 h 698157"/>
                          <a:gd name="connsiteX2" fmla="*/ 2126631 w 2171434"/>
                          <a:gd name="connsiteY2" fmla="*/ 698157 h 698157"/>
                          <a:gd name="connsiteX3" fmla="*/ 0 w 2171434"/>
                          <a:gd name="connsiteY3" fmla="*/ 512101 h 698157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</a:cxnLst>
                        <a:rect l="l" t="t" r="r" b="b"/>
                        <a:pathLst>
                          <a:path w="2171434" h="698157">
                            <a:moveTo>
                              <a:pt x="44803" y="0"/>
                            </a:moveTo>
                            <a:lnTo>
                              <a:pt x="2171434" y="186056"/>
                            </a:lnTo>
                            <a:lnTo>
                              <a:pt x="2126631" y="698157"/>
                            </a:lnTo>
                            <a:lnTo>
                              <a:pt x="0" y="512101"/>
                            </a:lnTo>
                            <a:close/>
                          </a:path>
                        </a:pathLst>
                      </a:custGeom>
                    </p:spPr>
                  </p:pic>
                  <p:sp>
                    <p:nvSpPr>
                      <p:cNvPr id="19" name="文本框 38">
                        <a:extLst>
                          <a:ext uri="{FF2B5EF4-FFF2-40B4-BE49-F238E27FC236}">
                            <a16:creationId xmlns:a16="http://schemas.microsoft.com/office/drawing/2014/main" id="{F6D96D7A-9880-15D1-A33F-344AB104A7B5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561494" y="1312986"/>
                        <a:ext cx="676246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square"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</a:p>
                    </p:txBody>
                  </p:sp>
                  <p:sp>
                    <p:nvSpPr>
                      <p:cNvPr id="20" name="文本框 33">
                        <a:extLst>
                          <a:ext uri="{FF2B5EF4-FFF2-40B4-BE49-F238E27FC236}">
                            <a16:creationId xmlns:a16="http://schemas.microsoft.com/office/drawing/2014/main" id="{C0D70E01-C68B-FD2A-FA07-8724806E2BA4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9500000">
                        <a:off x="2383518" y="1532706"/>
                        <a:ext cx="67310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</a:p>
                    </p:txBody>
                  </p:sp>
                  <p:sp>
                    <p:nvSpPr>
                      <p:cNvPr id="21" name="文本框 34">
                        <a:extLst>
                          <a:ext uri="{FF2B5EF4-FFF2-40B4-BE49-F238E27FC236}">
                            <a16:creationId xmlns:a16="http://schemas.microsoft.com/office/drawing/2014/main" id="{0FA4C347-E5F3-7D95-FD33-D6D8C41B37CA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9500000">
                        <a:off x="2786217" y="1532250"/>
                        <a:ext cx="674688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STL1</a:t>
                        </a:r>
                      </a:p>
                    </p:txBody>
                  </p:sp>
                  <p:sp>
                    <p:nvSpPr>
                      <p:cNvPr id="22" name="文本框 35">
                        <a:extLst>
                          <a:ext uri="{FF2B5EF4-FFF2-40B4-BE49-F238E27FC236}">
                            <a16:creationId xmlns:a16="http://schemas.microsoft.com/office/drawing/2014/main" id="{BFFC0E69-9923-34C8-70A3-CFFC2BFCAACC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9500000">
                        <a:off x="3597083" y="1532251"/>
                        <a:ext cx="674687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STL1</a:t>
                        </a:r>
                      </a:p>
                    </p:txBody>
                  </p:sp>
                  <p:sp>
                    <p:nvSpPr>
                      <p:cNvPr id="23" name="文本框 36">
                        <a:extLst>
                          <a:ext uri="{FF2B5EF4-FFF2-40B4-BE49-F238E27FC236}">
                            <a16:creationId xmlns:a16="http://schemas.microsoft.com/office/drawing/2014/main" id="{E26A5B84-EDAC-8F6D-0F9E-C0E761BD9649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 rot="19500000">
                        <a:off x="3174998" y="1532251"/>
                        <a:ext cx="674687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ontrol</a:t>
                        </a:r>
                      </a:p>
                    </p:txBody>
                  </p:sp>
                  <p:cxnSp>
                    <p:nvCxnSpPr>
                      <p:cNvPr id="24" name="直接连接符 23">
                        <a:extLst>
                          <a:ext uri="{FF2B5EF4-FFF2-40B4-BE49-F238E27FC236}">
                            <a16:creationId xmlns:a16="http://schemas.microsoft.com/office/drawing/2014/main" id="{FDAC0F50-2B7E-9403-9CBD-8B1FD8A4B2F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397993" y="1521013"/>
                        <a:ext cx="720000" cy="0"/>
                      </a:xfrm>
                      <a:prstGeom prst="line">
                        <a:avLst/>
                      </a:prstGeom>
                      <a:ln w="1270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5" name="直接连接符 24">
                        <a:extLst>
                          <a:ext uri="{FF2B5EF4-FFF2-40B4-BE49-F238E27FC236}">
                            <a16:creationId xmlns:a16="http://schemas.microsoft.com/office/drawing/2014/main" id="{D866258D-A3A1-F9B2-CDF6-30F6486EE8B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433965" y="1521013"/>
                        <a:ext cx="720000" cy="0"/>
                      </a:xfrm>
                      <a:prstGeom prst="line">
                        <a:avLst/>
                      </a:prstGeom>
                      <a:ln w="12700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6" name="文本框 25">
                        <a:extLst>
                          <a:ext uri="{FF2B5EF4-FFF2-40B4-BE49-F238E27FC236}">
                            <a16:creationId xmlns:a16="http://schemas.microsoft.com/office/drawing/2014/main" id="{B036B917-1191-EF92-ED5B-18F5EB39C7E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35566" y="2074113"/>
                        <a:ext cx="93071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zh-CN"/>
                        </a:defPPr>
                        <a:lvl1pPr algn="ctr">
                          <a:defRPr sz="12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pPr algn="l"/>
                        <a:r>
                          <a:rPr lang="en-US" altLang="zh-CN" sz="900" dirty="0"/>
                          <a:t>Cleaved-PARP</a:t>
                        </a:r>
                        <a:endParaRPr lang="zh-CN" altLang="en-US" sz="900" dirty="0"/>
                      </a:p>
                    </p:txBody>
                  </p:sp>
                  <p:sp>
                    <p:nvSpPr>
                      <p:cNvPr id="27" name="文本框 26">
                        <a:extLst>
                          <a:ext uri="{FF2B5EF4-FFF2-40B4-BE49-F238E27FC236}">
                            <a16:creationId xmlns:a16="http://schemas.microsoft.com/office/drawing/2014/main" id="{66B5A008-46E0-F4BF-F73C-C3C8076F92C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62266" y="2684401"/>
                        <a:ext cx="828000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zh-CN"/>
                        </a:defPPr>
                        <a:lvl1pPr algn="ctr">
                          <a:defRPr sz="12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pPr algn="l"/>
                        <a:r>
                          <a:rPr lang="en-US" altLang="zh-CN" sz="900" dirty="0"/>
                          <a:t>Cleaved-</a:t>
                        </a:r>
                      </a:p>
                      <a:p>
                        <a:pPr algn="l"/>
                        <a:r>
                          <a:rPr lang="en-US" altLang="zh-CN" sz="900" dirty="0"/>
                          <a:t>caspase-3</a:t>
                        </a:r>
                        <a:endParaRPr lang="zh-CN" altLang="en-US" sz="900" dirty="0"/>
                      </a:p>
                    </p:txBody>
                  </p:sp>
                  <p:sp>
                    <p:nvSpPr>
                      <p:cNvPr id="28" name="文本框 27">
                        <a:extLst>
                          <a:ext uri="{FF2B5EF4-FFF2-40B4-BE49-F238E27FC236}">
                            <a16:creationId xmlns:a16="http://schemas.microsoft.com/office/drawing/2014/main" id="{F43D1ABA-0F24-A410-0D84-066F8840FCA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38281" y="4506526"/>
                        <a:ext cx="828000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zh-CN"/>
                        </a:defPPr>
                        <a:lvl1pPr algn="ctr">
                          <a:defRPr sz="1200">
                            <a:latin typeface="Arial" panose="020B0604020202020204" pitchFamily="34" charset="0"/>
                            <a:cs typeface="Arial" panose="020B0604020202020204" pitchFamily="34" charset="0"/>
                          </a:defRPr>
                        </a:lvl1pPr>
                      </a:lstStyle>
                      <a:p>
                        <a:pPr algn="l"/>
                        <a:r>
                          <a:rPr lang="en-US" altLang="zh-CN" sz="900" dirty="0"/>
                          <a:t>GAPDH</a:t>
                        </a:r>
                        <a:endParaRPr lang="zh-CN" altLang="en-US" sz="900" dirty="0"/>
                      </a:p>
                    </p:txBody>
                  </p:sp>
                  <p:sp>
                    <p:nvSpPr>
                      <p:cNvPr id="29" name="文本框 28">
                        <a:extLst>
                          <a:ext uri="{FF2B5EF4-FFF2-40B4-BE49-F238E27FC236}">
                            <a16:creationId xmlns:a16="http://schemas.microsoft.com/office/drawing/2014/main" id="{8EF15820-4E20-A569-21F1-C386B647336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372797" y="1297597"/>
                        <a:ext cx="831898" cy="3231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NF</a:t>
                        </a:r>
                        <a:r>
                          <a:rPr lang="el-GR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α</a:t>
                        </a:r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CHX</a:t>
                        </a:r>
                      </a:p>
                      <a:p>
                        <a:endParaRPr lang="zh-CN" altLang="en-US" sz="9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30" name="文本框 46">
                        <a:extLst>
                          <a:ext uri="{FF2B5EF4-FFF2-40B4-BE49-F238E27FC236}">
                            <a16:creationId xmlns:a16="http://schemas.microsoft.com/office/drawing/2014/main" id="{9E8861FC-0076-6859-C7C9-834A9368D8E8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66135" y="2100077"/>
                        <a:ext cx="73025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31" name="文本框 30">
                        <a:extLst>
                          <a:ext uri="{FF2B5EF4-FFF2-40B4-BE49-F238E27FC236}">
                            <a16:creationId xmlns:a16="http://schemas.microsoft.com/office/drawing/2014/main" id="{18A3270A-9D1D-C9A1-F0B9-6EE95FA85E92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66135" y="2330270"/>
                        <a:ext cx="73025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70</a:t>
                        </a:r>
                      </a:p>
                    </p:txBody>
                  </p:sp>
                  <p:sp>
                    <p:nvSpPr>
                      <p:cNvPr id="32" name="文本框 31">
                        <a:extLst>
                          <a:ext uri="{FF2B5EF4-FFF2-40B4-BE49-F238E27FC236}">
                            <a16:creationId xmlns:a16="http://schemas.microsoft.com/office/drawing/2014/main" id="{E02B91E4-6779-3DFF-BEEF-72723231BE9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52249" y="1551859"/>
                        <a:ext cx="529874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W</a:t>
                        </a:r>
                      </a:p>
                      <a:p>
                        <a:pPr algn="ctr"/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</a:t>
                        </a:r>
                        <a:r>
                          <a:rPr lang="en-US" altLang="zh-CN" sz="90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Da</a:t>
                        </a:r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  <p:cxnSp>
                    <p:nvCxnSpPr>
                      <p:cNvPr id="33" name="直接箭头连接符 32">
                        <a:extLst>
                          <a:ext uri="{FF2B5EF4-FFF2-40B4-BE49-F238E27FC236}">
                            <a16:creationId xmlns:a16="http://schemas.microsoft.com/office/drawing/2014/main" id="{F550A1EA-5C69-95AC-E03C-F50BBB2D78F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56541" y="2205051"/>
                        <a:ext cx="31260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non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" name="直接箭头连接符 33">
                        <a:extLst>
                          <a:ext uri="{FF2B5EF4-FFF2-40B4-BE49-F238E27FC236}">
                            <a16:creationId xmlns:a16="http://schemas.microsoft.com/office/drawing/2014/main" id="{3B5E8AEA-A024-EB46-1BEC-B1883F54A27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56541" y="2419352"/>
                        <a:ext cx="31260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non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5" name="文本框 34">
                        <a:extLst>
                          <a:ext uri="{FF2B5EF4-FFF2-40B4-BE49-F238E27FC236}">
                            <a16:creationId xmlns:a16="http://schemas.microsoft.com/office/drawing/2014/main" id="{4EA3D9F6-C398-98CB-839C-AD7A23FFD6B9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66135" y="3118050"/>
                        <a:ext cx="73025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</a:t>
                        </a:r>
                      </a:p>
                    </p:txBody>
                  </p:sp>
                  <p:cxnSp>
                    <p:nvCxnSpPr>
                      <p:cNvPr id="36" name="直接箭头连接符 35">
                        <a:extLst>
                          <a:ext uri="{FF2B5EF4-FFF2-40B4-BE49-F238E27FC236}">
                            <a16:creationId xmlns:a16="http://schemas.microsoft.com/office/drawing/2014/main" id="{41F4EA0D-A093-B4F6-AB51-A0630D87044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95948" y="3222306"/>
                        <a:ext cx="31260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non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7" name="文本框 46">
                        <a:extLst>
                          <a:ext uri="{FF2B5EF4-FFF2-40B4-BE49-F238E27FC236}">
                            <a16:creationId xmlns:a16="http://schemas.microsoft.com/office/drawing/2014/main" id="{2AD15109-6BCF-4944-FC2E-76DFE8A9185D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66135" y="2480703"/>
                        <a:ext cx="73025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5</a:t>
                        </a:r>
                      </a:p>
                    </p:txBody>
                  </p:sp>
                  <p:sp>
                    <p:nvSpPr>
                      <p:cNvPr id="38" name="文本框 37">
                        <a:extLst>
                          <a:ext uri="{FF2B5EF4-FFF2-40B4-BE49-F238E27FC236}">
                            <a16:creationId xmlns:a16="http://schemas.microsoft.com/office/drawing/2014/main" id="{00ACBBEA-0F91-458F-346A-146311288BDD}"/>
                          </a:ext>
                        </a:extLst>
                      </p:cNvPr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4466135" y="4719664"/>
                        <a:ext cx="730250" cy="23083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/>
                      <a:p>
                        <a:r>
                          <a:rPr lang="en-US" altLang="zh-C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5</a:t>
                        </a:r>
                      </a:p>
                    </p:txBody>
                  </p:sp>
                  <p:cxnSp>
                    <p:nvCxnSpPr>
                      <p:cNvPr id="39" name="直接箭头连接符 38">
                        <a:extLst>
                          <a:ext uri="{FF2B5EF4-FFF2-40B4-BE49-F238E27FC236}">
                            <a16:creationId xmlns:a16="http://schemas.microsoft.com/office/drawing/2014/main" id="{26268348-7648-4F70-2791-69B06FE4B15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86552" y="2585611"/>
                        <a:ext cx="31260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non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" name="直接箭头连接符 39">
                        <a:extLst>
                          <a:ext uri="{FF2B5EF4-FFF2-40B4-BE49-F238E27FC236}">
                            <a16:creationId xmlns:a16="http://schemas.microsoft.com/office/drawing/2014/main" id="{CD45CFD6-C1DE-D491-8513-7AB9C6FBCC7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81786" y="4815735"/>
                        <a:ext cx="31260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non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1" name="矩形 40">
                        <a:extLst>
                          <a:ext uri="{FF2B5EF4-FFF2-40B4-BE49-F238E27FC236}">
                            <a16:creationId xmlns:a16="http://schemas.microsoft.com/office/drawing/2014/main" id="{7D1356F8-987E-9769-720C-1ECBAFFB6F7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82595" y="2072958"/>
                        <a:ext cx="1587378" cy="374143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olid"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9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2" name="矩形 41">
                        <a:extLst>
                          <a:ext uri="{FF2B5EF4-FFF2-40B4-BE49-F238E27FC236}">
                            <a16:creationId xmlns:a16="http://schemas.microsoft.com/office/drawing/2014/main" id="{250BB26E-8373-68F5-3AB3-B391B072998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92531" y="2800587"/>
                        <a:ext cx="1746557" cy="448454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olid"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9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3" name="矩形 42">
                        <a:extLst>
                          <a:ext uri="{FF2B5EF4-FFF2-40B4-BE49-F238E27FC236}">
                            <a16:creationId xmlns:a16="http://schemas.microsoft.com/office/drawing/2014/main" id="{6704547C-33EB-7CE2-7FCE-A1AC1C9B076C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33034" y="4579635"/>
                        <a:ext cx="1687311" cy="355474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rgbClr val="C00000"/>
                        </a:solidFill>
                        <a:prstDash val="solid"/>
                      </a:ln>
                    </p:spPr>
                    <p:style>
                      <a:lnRef idx="2">
                        <a:schemeClr val="accent1">
                          <a:shade val="15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90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pic>
                <p:nvPicPr>
                  <p:cNvPr id="7" name="图片 6">
                    <a:extLst>
                      <a:ext uri="{FF2B5EF4-FFF2-40B4-BE49-F238E27FC236}">
                        <a16:creationId xmlns:a16="http://schemas.microsoft.com/office/drawing/2014/main" id="{D5090966-F216-23FB-48B9-04C6AA3B866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rcRect l="-964" t="2784"/>
                  <a:stretch/>
                </p:blipFill>
                <p:spPr>
                  <a:xfrm>
                    <a:off x="1844711" y="3931344"/>
                    <a:ext cx="2180819" cy="1115555"/>
                  </a:xfrm>
                  <a:prstGeom prst="rect">
                    <a:avLst/>
                  </a:prstGeom>
                </p:spPr>
              </p:pic>
              <p:cxnSp>
                <p:nvCxnSpPr>
                  <p:cNvPr id="9" name="直接箭头连接符 8">
                    <a:extLst>
                      <a:ext uri="{FF2B5EF4-FFF2-40B4-BE49-F238E27FC236}">
                        <a16:creationId xmlns:a16="http://schemas.microsoft.com/office/drawing/2014/main" id="{B19BAFC5-9E8E-6AAB-8396-6D0AA3B75B6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48274" y="4205397"/>
                    <a:ext cx="31260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直接箭头连接符 9">
                    <a:extLst>
                      <a:ext uri="{FF2B5EF4-FFF2-40B4-BE49-F238E27FC236}">
                        <a16:creationId xmlns:a16="http://schemas.microsoft.com/office/drawing/2014/main" id="{0EA5D382-AEDF-71BA-A53F-2614A200F9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25010" y="4481895"/>
                    <a:ext cx="31260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直接箭头连接符 10">
                    <a:extLst>
                      <a:ext uri="{FF2B5EF4-FFF2-40B4-BE49-F238E27FC236}">
                        <a16:creationId xmlns:a16="http://schemas.microsoft.com/office/drawing/2014/main" id="{E93CC485-912E-C36A-E47D-D0FDECF4B7E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008867" y="4889021"/>
                    <a:ext cx="31260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A4B7A217-DC93-7C1F-1909-F026FE5007A1}"/>
                    </a:ext>
                  </a:extLst>
                </p:cNvPr>
                <p:cNvSpPr txBox="1"/>
                <p:nvPr/>
              </p:nvSpPr>
              <p:spPr>
                <a:xfrm>
                  <a:off x="1059058" y="4322838"/>
                  <a:ext cx="8280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algn="ctr">
                    <a:defRPr sz="12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pPr algn="l"/>
                  <a:r>
                    <a:rPr lang="en-US" altLang="zh-CN" sz="900" dirty="0"/>
                    <a:t>caspase-3</a:t>
                  </a:r>
                  <a:endParaRPr lang="zh-CN" altLang="en-US" sz="900" dirty="0"/>
                </a:p>
              </p:txBody>
            </p:sp>
          </p:grp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B1E7636C-AFBB-7865-8B31-D2CD028ABD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37612" y="4364357"/>
                <a:ext cx="7302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65C035CF-926C-2F0F-5948-68BD63374FB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46631" y="4765646"/>
                <a:ext cx="7302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2A3C358E-6D4F-9B3F-BC53-B9876BED005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60876" y="4089805"/>
                <a:ext cx="73025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r>
                  <a:rPr lang="en-US" altLang="zh-CN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</p:grp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4D2AD602-3CA8-A888-9B65-52C2C07EF59B}"/>
                </a:ext>
              </a:extLst>
            </p:cNvPr>
            <p:cNvSpPr/>
            <p:nvPr/>
          </p:nvSpPr>
          <p:spPr>
            <a:xfrm>
              <a:off x="2199140" y="4298292"/>
              <a:ext cx="1573531" cy="448454"/>
            </a:xfrm>
            <a:prstGeom prst="rect">
              <a:avLst/>
            </a:prstGeom>
            <a:noFill/>
            <a:ln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36966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8</TotalTime>
  <Words>34</Words>
  <Application>Microsoft Office PowerPoint</Application>
  <PresentationFormat>A4 纸张(210x297 毫米)</PresentationFormat>
  <Paragraphs>23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Imag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雨娜 黄</dc:creator>
  <cp:lastModifiedBy>春玲 黄</cp:lastModifiedBy>
  <cp:revision>9</cp:revision>
  <dcterms:created xsi:type="dcterms:W3CDTF">2024-07-04T15:35:09Z</dcterms:created>
  <dcterms:modified xsi:type="dcterms:W3CDTF">2025-05-16T02:14:26Z</dcterms:modified>
</cp:coreProperties>
</file>